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50"/>
    <p:restoredTop sz="94589"/>
  </p:normalViewPr>
  <p:slideViewPr>
    <p:cSldViewPr snapToGrid="0">
      <p:cViewPr varScale="1">
        <p:scale>
          <a:sx n="90" d="100"/>
          <a:sy n="90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635" y="2471420"/>
            <a:ext cx="6804660" cy="313817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04775" y="6159500"/>
            <a:ext cx="6699250" cy="922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8.Discriminative sequence motif analysis (STREME) of the 100-bp flanking regions surrounding the preferred versus abandoned alternative poly(A) site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Presentation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Carol Jenner</cp:lastModifiedBy>
  <cp:revision>936</cp:revision>
  <dcterms:created xsi:type="dcterms:W3CDTF">2015-11-14T07:04:00Z</dcterms:created>
  <dcterms:modified xsi:type="dcterms:W3CDTF">2026-06-11T08:35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35BD58706B7D4A4F949D01E48B3E8F39_13</vt:lpwstr>
  </property>
  <property fmtid="{D5CDD505-2E9C-101B-9397-08002B2CF9AE}" pid="14" name="KSOProductBuildVer">
    <vt:lpwstr>2052-12.1.0.22483</vt:lpwstr>
  </property>
</Properties>
</file>